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6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A040"/>
    <a:srgbClr val="55A0FB"/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28" d="100"/>
          <a:sy n="128" d="100"/>
        </p:scale>
        <p:origin x="456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60" d="100"/>
        <a:sy n="16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7E19196-A784-9D64-AFE9-9F9CC64E9C7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EBBC94A8-EF44-8A0A-1661-F1A4F374DDB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5A037480-CC22-7F13-480A-D3CD40CD5A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B63150-E30A-4B7C-B836-F6D082E006BA}" type="datetimeFigureOut">
              <a:rPr lang="de-DE" smtClean="0"/>
              <a:t>19.07.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9ECD6976-0BFC-B3BD-BD9A-BE89364A23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9FE80D3F-5E70-55CF-00B7-7F94346CFA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4631EF-A6EB-4B7C-8CED-D8DDC6D4106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141923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94E7B50-6711-954B-7F6D-C2B89D65DE9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82F89F6E-E1CD-93B2-7B39-769EAE45E57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2DAA5416-0968-F11A-4119-D7A5148602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B63150-E30A-4B7C-B836-F6D082E006BA}" type="datetimeFigureOut">
              <a:rPr lang="de-DE" smtClean="0"/>
              <a:t>19.07.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1576D6CB-7845-AA8E-C6FF-B6AC761E2D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6C867E78-C164-8167-CC27-E53A1AD0ED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4631EF-A6EB-4B7C-8CED-D8DDC6D4106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971900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83355020-7C76-E1ED-3997-230C28E09F8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951A59CF-E825-850D-B42D-4FAEF59B80B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62279E4A-E608-22F0-550B-8BF8173765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B63150-E30A-4B7C-B836-F6D082E006BA}" type="datetimeFigureOut">
              <a:rPr lang="de-DE" smtClean="0"/>
              <a:t>19.07.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A8352EAA-5ECF-2338-FD9E-6CAFB0D070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17653441-50AA-F437-E665-60E87CF4B1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4631EF-A6EB-4B7C-8CED-D8DDC6D4106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80464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36E5AA4-D76C-268A-6C54-C5491177B8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66EB5A48-A143-C842-2CAC-CB7F229A95F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EAC4721B-AF28-E925-B1A6-84BEEC829E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B63150-E30A-4B7C-B836-F6D082E006BA}" type="datetimeFigureOut">
              <a:rPr lang="de-DE" smtClean="0"/>
              <a:t>19.07.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D830F58E-3338-542E-52FB-1F89CBA2CE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BF148DA1-A633-3386-5A74-C369393212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4631EF-A6EB-4B7C-8CED-D8DDC6D4106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179548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DCD4D6A-D105-8A00-DFF7-A35383FED5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095CB9CB-55D7-2BD3-60CC-03361BE1EAD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C6D5673A-8A2D-7326-604A-A8BDE57B89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B63150-E30A-4B7C-B836-F6D082E006BA}" type="datetimeFigureOut">
              <a:rPr lang="de-DE" smtClean="0"/>
              <a:t>19.07.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D1741326-3F47-C3F0-A504-9CDCA8F3A6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463C9774-2A84-4E66-F192-860D01E1CE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4631EF-A6EB-4B7C-8CED-D8DDC6D4106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739042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E5E5CE3-4778-0C45-022B-606245EF02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65727497-FB50-39B4-0086-1A2A5CDB9B0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FCB8ADB0-0E2F-0669-7B1B-B47F4442953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21B5C1F4-5656-ABBC-26F0-091A8D8CD6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B63150-E30A-4B7C-B836-F6D082E006BA}" type="datetimeFigureOut">
              <a:rPr lang="de-DE" smtClean="0"/>
              <a:t>19.07.24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515E94AD-5BBD-E743-AAE1-D79DDF8705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0CEF3F5A-D508-7B8A-877B-604840A925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4631EF-A6EB-4B7C-8CED-D8DDC6D4106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431867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823F2E8-FEAB-9EE6-38E7-41B8D5D295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265E1B23-527C-20EE-5A5D-9EF686CCF81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D0C4B4CA-0564-D20B-C7D9-E305D0C76F6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61861AFC-01D6-B1D3-F334-7F4EF95C0CB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4AA2A3C0-A6BC-CFEA-1BA5-D2D091BCFD3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1580D4D0-E7AC-095D-8189-E8B1E19173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B63150-E30A-4B7C-B836-F6D082E006BA}" type="datetimeFigureOut">
              <a:rPr lang="de-DE" smtClean="0"/>
              <a:t>19.07.24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A9826D11-32ED-1EA7-6828-4A4FFB829F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DDA3785C-68AA-DC2C-B138-B6AF679D1A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4631EF-A6EB-4B7C-8CED-D8DDC6D4106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217492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7BD5742-4287-8057-A191-6A053F4E38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FE2C7FDE-190E-26DD-F34F-9C9263B9D2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B63150-E30A-4B7C-B836-F6D082E006BA}" type="datetimeFigureOut">
              <a:rPr lang="de-DE" smtClean="0"/>
              <a:t>19.07.24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F12296E2-95E1-1F2A-70C8-FA3A3D76F4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716739AE-FC5D-4B79-16C5-01AB0BF4D1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4631EF-A6EB-4B7C-8CED-D8DDC6D4106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987313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C9C7174E-5FDB-DD9C-E6A7-7FC226F3D0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B63150-E30A-4B7C-B836-F6D082E006BA}" type="datetimeFigureOut">
              <a:rPr lang="de-DE" smtClean="0"/>
              <a:t>19.07.24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D3C7E267-4700-F33D-8EE1-96678D56FA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4325A6F9-4A30-50AD-B188-8232EFB673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4631EF-A6EB-4B7C-8CED-D8DDC6D4106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22189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0392367-01E8-206E-5507-BBF59F3AD6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8BA3CAA3-1FAC-AE78-A0F2-93F1AB92867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3A45E53A-6AF0-62F1-4C2C-C5EEF885976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51D5E01A-579A-394C-C9FE-C42892EEEE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B63150-E30A-4B7C-B836-F6D082E006BA}" type="datetimeFigureOut">
              <a:rPr lang="de-DE" smtClean="0"/>
              <a:t>19.07.24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576D734F-5A7E-41E0-175C-1CBB4AB954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D270A3A6-D082-D575-F799-4A1846CA9C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4631EF-A6EB-4B7C-8CED-D8DDC6D4106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603622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3FBAB11-2E27-58D6-EF3D-B48A9822F0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F4CFB158-BE9A-D8C6-B7C9-1BD3F9A19EB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5E8BCFE4-B204-3516-1948-82DA32BBD52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0238403A-2655-BAE8-2DCD-7453E2BF31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B63150-E30A-4B7C-B836-F6D082E006BA}" type="datetimeFigureOut">
              <a:rPr lang="de-DE" smtClean="0"/>
              <a:t>19.07.24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1388B78C-0FAB-9A09-DC99-989AC76DC2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46D278E3-F04E-953B-3527-1F73468732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4631EF-A6EB-4B7C-8CED-D8DDC6D4106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182627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2C1717B5-E4FE-97FF-0346-85213A6C9E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800ACD64-039A-15CD-450C-FB9CF31AEF1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2BF87231-CD82-C03B-E839-39972D33BF7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B63150-E30A-4B7C-B836-F6D082E006BA}" type="datetimeFigureOut">
              <a:rPr lang="de-DE" smtClean="0"/>
              <a:t>19.07.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AEFCAFCF-C32B-30FE-2E2B-ACAFF2BFBE1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82ECC53F-0BA2-9DFB-775D-17F19E73FB0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4631EF-A6EB-4B7C-8CED-D8DDC6D4106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137108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elle 1">
            <a:extLst>
              <a:ext uri="{FF2B5EF4-FFF2-40B4-BE49-F238E27FC236}">
                <a16:creationId xmlns:a16="http://schemas.microsoft.com/office/drawing/2014/main" id="{A8A7508E-CB6A-C92A-A878-E083AB06B1B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06443335"/>
              </p:ext>
            </p:extLst>
          </p:nvPr>
        </p:nvGraphicFramePr>
        <p:xfrm>
          <a:off x="722363" y="1529218"/>
          <a:ext cx="10515599" cy="3799564"/>
        </p:xfrm>
        <a:graphic>
          <a:graphicData uri="http://schemas.openxmlformats.org/drawingml/2006/table">
            <a:tbl>
              <a:tblPr/>
              <a:tblGrid>
                <a:gridCol w="3313991">
                  <a:extLst>
                    <a:ext uri="{9D8B030D-6E8A-4147-A177-3AD203B41FA5}">
                      <a16:colId xmlns:a16="http://schemas.microsoft.com/office/drawing/2014/main" val="34891173"/>
                    </a:ext>
                  </a:extLst>
                </a:gridCol>
                <a:gridCol w="600134">
                  <a:extLst>
                    <a:ext uri="{9D8B030D-6E8A-4147-A177-3AD203B41FA5}">
                      <a16:colId xmlns:a16="http://schemas.microsoft.com/office/drawing/2014/main" val="1071368268"/>
                    </a:ext>
                  </a:extLst>
                </a:gridCol>
                <a:gridCol w="600134">
                  <a:extLst>
                    <a:ext uri="{9D8B030D-6E8A-4147-A177-3AD203B41FA5}">
                      <a16:colId xmlns:a16="http://schemas.microsoft.com/office/drawing/2014/main" val="810565321"/>
                    </a:ext>
                  </a:extLst>
                </a:gridCol>
                <a:gridCol w="600134">
                  <a:extLst>
                    <a:ext uri="{9D8B030D-6E8A-4147-A177-3AD203B41FA5}">
                      <a16:colId xmlns:a16="http://schemas.microsoft.com/office/drawing/2014/main" val="3026918953"/>
                    </a:ext>
                  </a:extLst>
                </a:gridCol>
                <a:gridCol w="600134">
                  <a:extLst>
                    <a:ext uri="{9D8B030D-6E8A-4147-A177-3AD203B41FA5}">
                      <a16:colId xmlns:a16="http://schemas.microsoft.com/office/drawing/2014/main" val="3503960869"/>
                    </a:ext>
                  </a:extLst>
                </a:gridCol>
                <a:gridCol w="600134">
                  <a:extLst>
                    <a:ext uri="{9D8B030D-6E8A-4147-A177-3AD203B41FA5}">
                      <a16:colId xmlns:a16="http://schemas.microsoft.com/office/drawing/2014/main" val="84840720"/>
                    </a:ext>
                  </a:extLst>
                </a:gridCol>
                <a:gridCol w="600134">
                  <a:extLst>
                    <a:ext uri="{9D8B030D-6E8A-4147-A177-3AD203B41FA5}">
                      <a16:colId xmlns:a16="http://schemas.microsoft.com/office/drawing/2014/main" val="3033739630"/>
                    </a:ext>
                  </a:extLst>
                </a:gridCol>
                <a:gridCol w="600134">
                  <a:extLst>
                    <a:ext uri="{9D8B030D-6E8A-4147-A177-3AD203B41FA5}">
                      <a16:colId xmlns:a16="http://schemas.microsoft.com/office/drawing/2014/main" val="997594903"/>
                    </a:ext>
                  </a:extLst>
                </a:gridCol>
                <a:gridCol w="600134">
                  <a:extLst>
                    <a:ext uri="{9D8B030D-6E8A-4147-A177-3AD203B41FA5}">
                      <a16:colId xmlns:a16="http://schemas.microsoft.com/office/drawing/2014/main" val="3689895097"/>
                    </a:ext>
                  </a:extLst>
                </a:gridCol>
                <a:gridCol w="600134">
                  <a:extLst>
                    <a:ext uri="{9D8B030D-6E8A-4147-A177-3AD203B41FA5}">
                      <a16:colId xmlns:a16="http://schemas.microsoft.com/office/drawing/2014/main" val="3289988480"/>
                    </a:ext>
                  </a:extLst>
                </a:gridCol>
                <a:gridCol w="600134">
                  <a:extLst>
                    <a:ext uri="{9D8B030D-6E8A-4147-A177-3AD203B41FA5}">
                      <a16:colId xmlns:a16="http://schemas.microsoft.com/office/drawing/2014/main" val="702849185"/>
                    </a:ext>
                  </a:extLst>
                </a:gridCol>
                <a:gridCol w="600134">
                  <a:extLst>
                    <a:ext uri="{9D8B030D-6E8A-4147-A177-3AD203B41FA5}">
                      <a16:colId xmlns:a16="http://schemas.microsoft.com/office/drawing/2014/main" val="1063581980"/>
                    </a:ext>
                  </a:extLst>
                </a:gridCol>
                <a:gridCol w="600134">
                  <a:extLst>
                    <a:ext uri="{9D8B030D-6E8A-4147-A177-3AD203B41FA5}">
                      <a16:colId xmlns:a16="http://schemas.microsoft.com/office/drawing/2014/main" val="940209027"/>
                    </a:ext>
                  </a:extLst>
                </a:gridCol>
              </a:tblGrid>
              <a:tr h="216710"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4">
                  <a:txBody>
                    <a:bodyPr/>
                    <a:lstStyle/>
                    <a:p>
                      <a:pPr algn="ctr" fontAlgn="b"/>
                      <a:r>
                        <a:rPr lang="de-DE" sz="13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st</a:t>
                      </a:r>
                    </a:p>
                  </a:txBody>
                  <a:tcPr marL="6192" marR="6192" marT="6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 fontAlgn="b"/>
                      <a:r>
                        <a:rPr lang="de-DE" sz="13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nd</a:t>
                      </a:r>
                    </a:p>
                  </a:txBody>
                  <a:tcPr marL="6192" marR="6192" marT="6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 fontAlgn="b"/>
                      <a:r>
                        <a:rPr lang="de-DE" sz="13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rd</a:t>
                      </a:r>
                    </a:p>
                  </a:txBody>
                  <a:tcPr marL="6192" marR="6192" marT="6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98743861"/>
                  </a:ext>
                </a:extLst>
              </a:tr>
              <a:tr h="216710">
                <a:tc>
                  <a:txBody>
                    <a:bodyPr/>
                    <a:lstStyle/>
                    <a:p>
                      <a:pPr algn="l" fontAlgn="b"/>
                      <a:endParaRPr lang="de-DE" sz="13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3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Δ</a:t>
                      </a:r>
                      <a:r>
                        <a:rPr lang="de-DE" sz="13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</a:t>
                      </a:r>
                    </a:p>
                  </a:txBody>
                  <a:tcPr marL="6192" marR="6192" marT="6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3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D420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3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D595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3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3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Δ</a:t>
                      </a:r>
                      <a:r>
                        <a:rPr lang="de-DE" sz="13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</a:t>
                      </a:r>
                    </a:p>
                  </a:txBody>
                  <a:tcPr marL="6192" marR="6192" marT="6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3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D420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3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D595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3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3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Δ</a:t>
                      </a:r>
                      <a:r>
                        <a:rPr lang="de-DE" sz="13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</a:t>
                      </a:r>
                    </a:p>
                  </a:txBody>
                  <a:tcPr marL="6192" marR="6192" marT="6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3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D420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3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D595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3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23952009"/>
                  </a:ext>
                </a:extLst>
              </a:tr>
              <a:tr h="148601"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P3331 (control)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</a:p>
                  </a:txBody>
                  <a:tcPr marL="6192" marR="6192" marT="6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127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253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,3306522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</a:p>
                  </a:txBody>
                  <a:tcPr marL="6192" marR="6192" marT="6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133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286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6,6267308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</a:p>
                  </a:txBody>
                  <a:tcPr marL="6192" marR="6192" marT="6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137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285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,1975614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51892029"/>
                  </a:ext>
                </a:extLst>
              </a:tr>
              <a:tr h="148601"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P3331 (Fe)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</a:p>
                  </a:txBody>
                  <a:tcPr marL="6192" marR="6192" marT="6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046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24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,2174583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</a:p>
                  </a:txBody>
                  <a:tcPr marL="6192" marR="6192" marT="6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043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205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,0311951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</a:p>
                  </a:txBody>
                  <a:tcPr marL="6192" marR="6192" marT="6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041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214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,2096495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06114881"/>
                  </a:ext>
                </a:extLst>
              </a:tr>
              <a:tr h="148601"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P3366 (control)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</a:p>
                  </a:txBody>
                  <a:tcPr marL="6192" marR="6192" marT="6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001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205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48909756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</a:p>
                  </a:txBody>
                  <a:tcPr marL="6192" marR="6192" marT="6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187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</a:p>
                  </a:txBody>
                  <a:tcPr marL="6192" marR="6192" marT="6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001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187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53617647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32401669"/>
                  </a:ext>
                </a:extLst>
              </a:tr>
              <a:tr h="148601"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P3366 (</a:t>
                      </a:r>
                      <a:r>
                        <a:rPr lang="de-DE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</a:t>
                      </a:r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</a:p>
                  </a:txBody>
                  <a:tcPr marL="6192" marR="6192" marT="6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011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213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,17800469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</a:p>
                  </a:txBody>
                  <a:tcPr marL="6192" marR="6192" marT="6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01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213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,707277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</a:p>
                  </a:txBody>
                  <a:tcPr marL="6192" marR="6192" marT="6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01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25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,0106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81146526"/>
                  </a:ext>
                </a:extLst>
              </a:tr>
              <a:tr h="148601"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P3356 (control)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,5</a:t>
                      </a:r>
                    </a:p>
                  </a:txBody>
                  <a:tcPr marL="6192" marR="6192" marT="6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352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273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34,23531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,5</a:t>
                      </a:r>
                    </a:p>
                  </a:txBody>
                  <a:tcPr marL="6192" marR="6192" marT="6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365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28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45,62071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,5</a:t>
                      </a:r>
                    </a:p>
                  </a:txBody>
                  <a:tcPr marL="6192" marR="6192" marT="6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375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287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48,0662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38138072"/>
                  </a:ext>
                </a:extLst>
              </a:tr>
              <a:tr h="148601"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P3356 (Fe)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,5</a:t>
                      </a:r>
                    </a:p>
                  </a:txBody>
                  <a:tcPr marL="6192" marR="6192" marT="6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294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202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67,44198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,5</a:t>
                      </a:r>
                    </a:p>
                  </a:txBody>
                  <a:tcPr marL="6192" marR="6192" marT="6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305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243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6,77613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,5</a:t>
                      </a:r>
                    </a:p>
                  </a:txBody>
                  <a:tcPr marL="6192" marR="6192" marT="6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263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213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0,41108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52568128"/>
                  </a:ext>
                </a:extLst>
              </a:tr>
              <a:tr h="148601"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P3361 (control)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,5</a:t>
                      </a:r>
                    </a:p>
                  </a:txBody>
                  <a:tcPr marL="6192" marR="6192" marT="6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337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248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89,97758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,5</a:t>
                      </a:r>
                    </a:p>
                  </a:txBody>
                  <a:tcPr marL="6192" marR="6192" marT="6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362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279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40,74351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,5</a:t>
                      </a:r>
                    </a:p>
                  </a:txBody>
                  <a:tcPr marL="6192" marR="6192" marT="6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354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268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59,51672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37160744"/>
                  </a:ext>
                </a:extLst>
              </a:tr>
              <a:tr h="148601"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P3361 (Fe)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,5</a:t>
                      </a:r>
                    </a:p>
                  </a:txBody>
                  <a:tcPr marL="6192" marR="6192" marT="6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31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218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40,62936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,5</a:t>
                      </a:r>
                    </a:p>
                  </a:txBody>
                  <a:tcPr marL="6192" marR="6192" marT="6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315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229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03,35284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,5</a:t>
                      </a:r>
                    </a:p>
                  </a:txBody>
                  <a:tcPr marL="6192" marR="6192" marT="6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306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228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76,52947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81228798"/>
                  </a:ext>
                </a:extLst>
              </a:tr>
              <a:tr h="148601"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P3331 + pBQ200 (control)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</a:p>
                  </a:txBody>
                  <a:tcPr marL="6192" marR="6192" marT="6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05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089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6,3286517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</a:p>
                  </a:txBody>
                  <a:tcPr marL="6192" marR="6192" marT="6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048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09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3,4746667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</a:p>
                  </a:txBody>
                  <a:tcPr marL="6192" marR="6192" marT="6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046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106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3,5112264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84011513"/>
                  </a:ext>
                </a:extLst>
              </a:tr>
              <a:tr h="148601"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P3331 + pBQ200 (Fe)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</a:p>
                  </a:txBody>
                  <a:tcPr marL="6192" marR="6192" marT="6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012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113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,6476106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</a:p>
                  </a:txBody>
                  <a:tcPr marL="6192" marR="6192" marT="6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012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127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,47385827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</a:p>
                  </a:txBody>
                  <a:tcPr marL="6192" marR="6192" marT="6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013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127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,2633465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61127106"/>
                  </a:ext>
                </a:extLst>
              </a:tr>
              <a:tr h="148601"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P3331 + pGP3897 (control)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</a:p>
                  </a:txBody>
                  <a:tcPr marL="6192" marR="6192" marT="6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25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053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72,948113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</a:p>
                  </a:txBody>
                  <a:tcPr marL="6192" marR="6192" marT="6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251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062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5,911532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</a:p>
                  </a:txBody>
                  <a:tcPr marL="6192" marR="6192" marT="6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468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1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69,2402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00850236"/>
                  </a:ext>
                </a:extLst>
              </a:tr>
              <a:tr h="148601"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P3331 + pGP3897 (Fe)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</a:p>
                  </a:txBody>
                  <a:tcPr marL="6192" marR="6192" marT="6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55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335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4,614179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</a:p>
                  </a:txBody>
                  <a:tcPr marL="6192" marR="6192" marT="6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121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073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6,192671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</a:p>
                  </a:txBody>
                  <a:tcPr marL="6192" marR="6192" marT="6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134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085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8,064824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05264724"/>
                  </a:ext>
                </a:extLst>
              </a:tr>
            </a:tbl>
          </a:graphicData>
        </a:graphic>
      </p:graphicFrame>
      <p:sp>
        <p:nvSpPr>
          <p:cNvPr id="4" name="Textfeld 3">
            <a:extLst>
              <a:ext uri="{FF2B5EF4-FFF2-40B4-BE49-F238E27FC236}">
                <a16:creationId xmlns:a16="http://schemas.microsoft.com/office/drawing/2014/main" id="{4877C780-7B2D-4EEC-5EC5-883631AAB1BD}"/>
              </a:ext>
            </a:extLst>
          </p:cNvPr>
          <p:cNvSpPr txBox="1"/>
          <p:nvPr/>
        </p:nvSpPr>
        <p:spPr>
          <a:xfrm>
            <a:off x="0" y="0"/>
            <a:ext cx="39231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>
                <a:latin typeface="Tenorite" panose="00000500000000000000" pitchFamily="2" charset="0"/>
              </a:rPr>
              <a:t>Supplementary</a:t>
            </a:r>
            <a:r>
              <a:rPr lang="de-DE" dirty="0">
                <a:latin typeface="Tenorite" panose="00000500000000000000" pitchFamily="2" charset="0"/>
              </a:rPr>
              <a:t> Figure 13 (Raw </a:t>
            </a:r>
            <a:r>
              <a:rPr lang="de-DE" dirty="0" err="1">
                <a:latin typeface="Tenorite" panose="00000500000000000000" pitchFamily="2" charset="0"/>
              </a:rPr>
              <a:t>data</a:t>
            </a:r>
            <a:r>
              <a:rPr lang="de-DE" dirty="0">
                <a:latin typeface="Tenorite" panose="00000500000000000000" pitchFamily="2" charset="0"/>
              </a:rPr>
              <a:t>) </a:t>
            </a:r>
          </a:p>
        </p:txBody>
      </p:sp>
    </p:spTree>
    <p:extLst>
      <p:ext uri="{BB962C8B-B14F-4D97-AF65-F5344CB8AC3E}">
        <p14:creationId xmlns:p14="http://schemas.microsoft.com/office/powerpoint/2010/main" val="36839434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25</Words>
  <Application>Microsoft Macintosh PowerPoint</Application>
  <PresentationFormat>Widescreen</PresentationFormat>
  <Paragraphs>17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enorite</vt:lpstr>
      <vt:lpstr>Offic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Robert Warneke</dc:creator>
  <cp:lastModifiedBy>TU-Pseudonym 9837692817497485</cp:lastModifiedBy>
  <cp:revision>7</cp:revision>
  <dcterms:created xsi:type="dcterms:W3CDTF">2024-07-15T14:26:38Z</dcterms:created>
  <dcterms:modified xsi:type="dcterms:W3CDTF">2024-07-19T16:23:04Z</dcterms:modified>
</cp:coreProperties>
</file>